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. Miriam Schulz-Raffelt" initials="DMS" lastIdx="6" clrIdx="0">
    <p:extLst>
      <p:ext uri="{19B8F6BF-5375-455C-9EA6-DF929625EA0E}">
        <p15:presenceInfo xmlns:p15="http://schemas.microsoft.com/office/powerpoint/2012/main" userId="S-1-5-21-1036228674-4065426080-1347446729-9644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4660"/>
  </p:normalViewPr>
  <p:slideViewPr>
    <p:cSldViewPr>
      <p:cViewPr varScale="1">
        <p:scale>
          <a:sx n="64" d="100"/>
          <a:sy n="64" d="100"/>
        </p:scale>
        <p:origin x="3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441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944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5166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047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185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927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584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229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61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891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7953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439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467191" y="7444879"/>
            <a:ext cx="591244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2.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22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P22F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.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tif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op of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ed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ck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emen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ensu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TCnnGAAnnTTC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ATA-box,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5’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ranslated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ion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UTR),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don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G,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end of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on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lational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p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don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AG, and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’-UTR.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-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TRs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caus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ensu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ed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fter 16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-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TR. 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2"/>
          <a:srcRect r="11998"/>
          <a:stretch/>
        </p:blipFill>
        <p:spPr>
          <a:xfrm>
            <a:off x="577705" y="598346"/>
            <a:ext cx="5801928" cy="68333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6082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Schroda</dc:creator>
  <cp:lastModifiedBy>Michael Schroda</cp:lastModifiedBy>
  <cp:revision>132</cp:revision>
  <cp:lastPrinted>2017-03-09T10:05:08Z</cp:lastPrinted>
  <dcterms:created xsi:type="dcterms:W3CDTF">2015-12-19T06:48:26Z</dcterms:created>
  <dcterms:modified xsi:type="dcterms:W3CDTF">2017-04-30T09:33:29Z</dcterms:modified>
</cp:coreProperties>
</file>